
<file path=[Content_Types].xml><?xml version="1.0" encoding="utf-8"?>
<Types xmlns="http://schemas.openxmlformats.org/package/2006/content-types">
  <Default Extension="png" ContentType="image/png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Default Extension="jpeg" ContentType="image/jpeg"/>
  <Default Extension="rels" ContentType="application/vnd.openxmlformats-package.relationships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59" r:id="rId3"/>
    <p:sldId id="257" r:id="rId4"/>
    <p:sldId id="258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123" d="100"/>
          <a:sy n="123" d="100"/>
        </p:scale>
        <p:origin x="-120" y="-31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12" Type="http://schemas.openxmlformats.org/officeDocument/2006/relationships/customXml" Target="../customXml/item3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11" Type="http://schemas.openxmlformats.org/officeDocument/2006/relationships/customXml" Target="../customXml/item2.xml"/><Relationship Id="rId5" Type="http://schemas.openxmlformats.org/officeDocument/2006/relationships/slide" Target="slides/slide4.xml"/><Relationship Id="rId10" Type="http://schemas.openxmlformats.org/officeDocument/2006/relationships/customXml" Target="../customXml/item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FD1D6D-A548-4C4C-8842-8BD0AFCC49A7}" type="datetimeFigureOut">
              <a:rPr lang="en-AU" smtClean="0"/>
              <a:t>24/10/201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62F440-7A19-4ACC-AC32-2519FD119B8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3729380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FD1D6D-A548-4C4C-8842-8BD0AFCC49A7}" type="datetimeFigureOut">
              <a:rPr lang="en-AU" smtClean="0"/>
              <a:t>24/10/201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62F440-7A19-4ACC-AC32-2519FD119B8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4082131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FD1D6D-A548-4C4C-8842-8BD0AFCC49A7}" type="datetimeFigureOut">
              <a:rPr lang="en-AU" smtClean="0"/>
              <a:t>24/10/201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62F440-7A19-4ACC-AC32-2519FD119B8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6754708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FD1D6D-A548-4C4C-8842-8BD0AFCC49A7}" type="datetimeFigureOut">
              <a:rPr lang="en-AU" smtClean="0"/>
              <a:t>24/10/201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62F440-7A19-4ACC-AC32-2519FD119B8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181454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FD1D6D-A548-4C4C-8842-8BD0AFCC49A7}" type="datetimeFigureOut">
              <a:rPr lang="en-AU" smtClean="0"/>
              <a:t>24/10/201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62F440-7A19-4ACC-AC32-2519FD119B8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0683237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FD1D6D-A548-4C4C-8842-8BD0AFCC49A7}" type="datetimeFigureOut">
              <a:rPr lang="en-AU" smtClean="0"/>
              <a:t>24/10/2016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62F440-7A19-4ACC-AC32-2519FD119B8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9858242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FD1D6D-A548-4C4C-8842-8BD0AFCC49A7}" type="datetimeFigureOut">
              <a:rPr lang="en-AU" smtClean="0"/>
              <a:t>24/10/2016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62F440-7A19-4ACC-AC32-2519FD119B8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0578734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FD1D6D-A548-4C4C-8842-8BD0AFCC49A7}" type="datetimeFigureOut">
              <a:rPr lang="en-AU" smtClean="0"/>
              <a:t>24/10/2016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62F440-7A19-4ACC-AC32-2519FD119B8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2178923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FD1D6D-A548-4C4C-8842-8BD0AFCC49A7}" type="datetimeFigureOut">
              <a:rPr lang="en-AU" smtClean="0"/>
              <a:t>24/10/2016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62F440-7A19-4ACC-AC32-2519FD119B8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338428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FD1D6D-A548-4C4C-8842-8BD0AFCC49A7}" type="datetimeFigureOut">
              <a:rPr lang="en-AU" smtClean="0"/>
              <a:t>24/10/2016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62F440-7A19-4ACC-AC32-2519FD119B8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6485018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FD1D6D-A548-4C4C-8842-8BD0AFCC49A7}" type="datetimeFigureOut">
              <a:rPr lang="en-AU" smtClean="0"/>
              <a:t>24/10/2016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62F440-7A19-4ACC-AC32-2519FD119B8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968931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FD1D6D-A548-4C4C-8842-8BD0AFCC49A7}" type="datetimeFigureOut">
              <a:rPr lang="en-AU" smtClean="0"/>
              <a:t>24/10/201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62F440-7A19-4ACC-AC32-2519FD119B8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379410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01674" y="0"/>
            <a:ext cx="11045825" cy="6023139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105338" y="6322128"/>
            <a:ext cx="11929095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AU" dirty="0"/>
              <a:t>Supplementary Figure </a:t>
            </a:r>
            <a:r>
              <a:rPr lang="en-AU" dirty="0" smtClean="0"/>
              <a:t>1A: </a:t>
            </a:r>
            <a:r>
              <a:rPr lang="en-AU" dirty="0"/>
              <a:t>Comparison between linkage groups </a:t>
            </a:r>
            <a:r>
              <a:rPr lang="en-AU" dirty="0" smtClean="0"/>
              <a:t>(LGs) of </a:t>
            </a:r>
            <a:r>
              <a:rPr lang="en-AU" dirty="0"/>
              <a:t>IH × NF</a:t>
            </a:r>
            <a:r>
              <a:rPr lang="en-AU" dirty="0" smtClean="0"/>
              <a:t>, IH </a:t>
            </a:r>
            <a:r>
              <a:rPr lang="en-AU" dirty="0"/>
              <a:t>× DIG, and NF × DIG maps.</a:t>
            </a:r>
          </a:p>
        </p:txBody>
      </p:sp>
    </p:spTree>
    <p:extLst>
      <p:ext uri="{BB962C8B-B14F-4D97-AF65-F5344CB8AC3E}">
        <p14:creationId xmlns:p14="http://schemas.microsoft.com/office/powerpoint/2010/main" val="353257632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91221" y="6330434"/>
            <a:ext cx="8867043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AU" dirty="0"/>
              <a:t>Supplementary Figure 1B: Comparison between </a:t>
            </a:r>
            <a:r>
              <a:rPr lang="en-AU" dirty="0" smtClean="0"/>
              <a:t>LG 5 </a:t>
            </a:r>
            <a:r>
              <a:rPr lang="en-AU" dirty="0"/>
              <a:t>of IH × NF, IH × DIG, and NF × DIG maps.</a:t>
            </a:r>
          </a:p>
          <a:p>
            <a:endParaRPr lang="en-AU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15987" y="0"/>
            <a:ext cx="10334625" cy="56292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9963832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91221" y="6330434"/>
            <a:ext cx="8865440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AU" dirty="0"/>
              <a:t>Supplementary Figure 1C: Comparison between </a:t>
            </a:r>
            <a:r>
              <a:rPr lang="en-AU" dirty="0" smtClean="0"/>
              <a:t>LG 7 </a:t>
            </a:r>
            <a:r>
              <a:rPr lang="en-AU" dirty="0"/>
              <a:t>of IH × NF, IH × DIG, and NF × DIG maps.</a:t>
            </a:r>
          </a:p>
          <a:p>
            <a:endParaRPr lang="en-AU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47712" y="0"/>
            <a:ext cx="10860088" cy="611706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2380725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91221" y="6330434"/>
            <a:ext cx="9001695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AU" dirty="0"/>
              <a:t>Supplementary Figure 1D: Comparison </a:t>
            </a:r>
            <a:r>
              <a:rPr lang="en-AU"/>
              <a:t>between </a:t>
            </a:r>
            <a:r>
              <a:rPr lang="en-AU" smtClean="0"/>
              <a:t>LG 6 </a:t>
            </a:r>
            <a:r>
              <a:rPr lang="en-AU" dirty="0"/>
              <a:t>of IH × NF, IH × DIG, and NF × DIG maps.</a:t>
            </a:r>
          </a:p>
          <a:p>
            <a:endParaRPr lang="en-AU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87387" y="0"/>
            <a:ext cx="10971213" cy="605950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868658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6F3304DEAE09B24DA68D64CBB702879E" ma:contentTypeVersion="7" ma:contentTypeDescription="Create a new document." ma:contentTypeScope="" ma:versionID="56f4917bd8fe5572caa8ce3e64525f08">
  <xsd:schema xmlns:xsd="http://www.w3.org/2001/XMLSchema" xmlns:p="http://schemas.microsoft.com/office/2006/metadata/properties" xmlns:ns2="28de4f29-e3d9-478e-b05a-16a8ff0eb393" targetNamespace="http://schemas.microsoft.com/office/2006/metadata/properties" ma:root="true" ma:fieldsID="90fc53ae50983f9ac236714ed868e368" ns2:_="">
    <xsd:import namespace="28de4f29-e3d9-478e-b05a-16a8ff0eb393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28de4f29-e3d9-478e-b05a-16a8ff0eb393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DocumentId xmlns="28de4f29-e3d9-478e-b05a-16a8ff0eb393">Presentation 1.pptx</DocumentId>
    <StageName xmlns="28de4f29-e3d9-478e-b05a-16a8ff0eb393">Author's Proof</StageName>
    <IsDeleted xmlns="28de4f29-e3d9-478e-b05a-16a8ff0eb393">false</IsDeleted>
    <FileFormat xmlns="28de4f29-e3d9-478e-b05a-16a8ff0eb393">PPTX</FileFormat>
    <TitleName xmlns="28de4f29-e3d9-478e-b05a-16a8ff0eb393">Presentation 1.pptx</TitleName>
    <DocumentType xmlns="28de4f29-e3d9-478e-b05a-16a8ff0eb393">Presentation</DocumentType>
    <Checked_x0020_Out_x0020_To xmlns="28de4f29-e3d9-478e-b05a-16a8ff0eb393">
      <UserInfo>
        <DisplayName/>
        <AccountId xsi:nil="true"/>
        <AccountType/>
      </UserInfo>
    </Checked_x0020_Out_x0020_To>
  </documentManagement>
</p:properties>
</file>

<file path=customXml/itemProps1.xml><?xml version="1.0" encoding="utf-8"?>
<ds:datastoreItem xmlns:ds="http://schemas.openxmlformats.org/officeDocument/2006/customXml" ds:itemID="{334D1A0A-4E85-4B6E-A859-3C24CBB28B0C}"/>
</file>

<file path=customXml/itemProps2.xml><?xml version="1.0" encoding="utf-8"?>
<ds:datastoreItem xmlns:ds="http://schemas.openxmlformats.org/officeDocument/2006/customXml" ds:itemID="{ED12B2C4-93C4-4884-86D2-4373C9A8B6C9}"/>
</file>

<file path=customXml/itemProps3.xml><?xml version="1.0" encoding="utf-8"?>
<ds:datastoreItem xmlns:ds="http://schemas.openxmlformats.org/officeDocument/2006/customXml" ds:itemID="{7DCE03E8-1106-4AA2-9590-D39EBDAD7059}"/>
</file>

<file path=docProps/app.xml><?xml version="1.0" encoding="utf-8"?>
<Properties xmlns="http://schemas.openxmlformats.org/officeDocument/2006/extended-properties" xmlns:vt="http://schemas.openxmlformats.org/officeDocument/2006/docPropsVTypes">
  <TotalTime>20</TotalTime>
  <Words>95</Words>
  <Application>Microsoft Office PowerPoint</Application>
  <PresentationFormat>Custom</PresentationFormat>
  <Paragraphs>4</Paragraphs>
  <Slides>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IMNA</dc:creator>
  <cp:lastModifiedBy>Shimna Sudheesh</cp:lastModifiedBy>
  <cp:revision>14</cp:revision>
  <dcterms:created xsi:type="dcterms:W3CDTF">2016-03-27T10:38:41Z</dcterms:created>
  <dcterms:modified xsi:type="dcterms:W3CDTF">2016-10-23T22:23:41Z</dcterms:modified>
</cp:coreProperties>
</file>